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229F97-26F2-4FBA-9CE4-7CBEAFBDB81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D4726B-FE72-4BD3-B00F-728A2D4554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FB656F-BC9B-428E-9269-FAB1661FFB8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735156-BCFC-44EC-B574-0AEFC93FF85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15F152-4580-49C2-9527-90408AFCD4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A16128-9AC1-4725-A0E3-E9545AB817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A677C4-015A-4167-AF73-68E42FD95C3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DBB6D55-78A2-4AC4-B0BA-AD34A979888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6369DD-3D9D-45CD-936B-D6ECC5525F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D9AFA0-3533-4FD7-A318-7FDB1722CBB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36E8FA-54EF-4473-B4DC-4EAFCA5BB3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DE042D-430D-453B-A92C-E64C32506E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71EABD2-839D-4D62-B6A7-C5F61EF48E51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Placeholder 8" descr=""/>
          <p:cNvPicPr/>
          <p:nvPr/>
        </p:nvPicPr>
        <p:blipFill>
          <a:blip r:embed="rId1"/>
          <a:srcRect l="4360" t="0" r="4360" b="0"/>
          <a:stretch/>
        </p:blipFill>
        <p:spPr>
          <a:xfrm>
            <a:off x="1549440" y="438120"/>
            <a:ext cx="5918040" cy="4438800"/>
          </a:xfrm>
          <a:prstGeom prst="rect">
            <a:avLst/>
          </a:prstGeom>
          <a:ln w="0">
            <a:noFill/>
          </a:ln>
        </p:spPr>
      </p:pic>
      <p:sp>
        <p:nvSpPr>
          <p:cNvPr id="42" name="PlaceHolder 1"/>
          <p:cNvSpPr>
            <a:spLocks noGrp="1"/>
          </p:cNvSpPr>
          <p:nvPr>
            <p:ph/>
          </p:nvPr>
        </p:nvSpPr>
        <p:spPr>
          <a:xfrm>
            <a:off x="1792440" y="4952520"/>
            <a:ext cx="5827680" cy="12956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 algn="just">
              <a:lnSpc>
                <a:spcPct val="9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Figure S1. Fit of FH18-20 rigid body models refined against the SAXS data using the program CORAL. 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Fits are shown for rigid body models refining only CCP 18 (CCPs 19-20 fixed) or CCP 20 (CCPs 18-19 fixed), as solid blue and dashed red lines, respectively.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lnSpc>
                <a:spcPct val="90000"/>
              </a:lnSpc>
              <a:spcBef>
                <a:spcPts val="4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1-27T19:26:05Z</dcterms:created>
  <dc:creator>Hannan, Jonathan</dc:creator>
  <dc:description/>
  <dc:language>en-US</dc:language>
  <cp:lastModifiedBy>Hannan, Jonathan</cp:lastModifiedBy>
  <dcterms:modified xsi:type="dcterms:W3CDTF">2012-01-27T19:31:16Z</dcterms:modified>
  <cp:revision>1</cp:revision>
  <dc:subject/>
  <dc:title>PowerPoint Presentation</dc:title>
</cp:coreProperties>
</file>